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 showGuides="1">
      <p:cViewPr varScale="1">
        <p:scale>
          <a:sx n="124" d="100"/>
          <a:sy n="124" d="100"/>
        </p:scale>
        <p:origin x="544" y="16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Tom/Desktop/EMETINE%20DRAFT/EMT%20TEXT%20FIGURES%20WORKING/MANUSCRIPT/July_2023/Dec%202%202021%20purom%20lab%20VERO%20E%20isoemetine%20ChemMaster_COPY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Re-plot 7-31-23'!$W$9</c:f>
              <c:strCache>
                <c:ptCount val="1"/>
                <c:pt idx="0">
                  <c:v>average %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Re-plot 7-31-23'!$U$10:$V$11</c:f>
              <c:strCache>
                <c:ptCount val="2"/>
                <c:pt idx="0">
                  <c:v>EMT</c:v>
                </c:pt>
                <c:pt idx="1">
                  <c:v>DHE4</c:v>
                </c:pt>
              </c:strCache>
            </c:strRef>
          </c:cat>
          <c:val>
            <c:numRef>
              <c:f>'Re-plot 7-31-23'!$W$10:$W$11</c:f>
              <c:numCache>
                <c:formatCode>General</c:formatCode>
                <c:ptCount val="2"/>
                <c:pt idx="0">
                  <c:v>68.158411189143038</c:v>
                </c:pt>
                <c:pt idx="1">
                  <c:v>59.1389720210485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18E-2A4F-8549-F896AB7E54F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26020752"/>
        <c:axId val="1826111152"/>
      </c:barChart>
      <c:catAx>
        <c:axId val="18260207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317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26111152"/>
        <c:crosses val="autoZero"/>
        <c:auto val="1"/>
        <c:lblAlgn val="ctr"/>
        <c:lblOffset val="100"/>
        <c:noMultiLvlLbl val="0"/>
      </c:catAx>
      <c:valAx>
        <c:axId val="1826111152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28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2800" b="1"/>
                  <a:t>Puromycilation, %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28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317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2602075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EA53C5-081D-F195-67C2-9326D5034CD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07B0000-B296-3D0B-B1AF-77CB8979A2D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B4E199-2242-4384-628B-7C3AD94126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4E27A-3637-3348-BBFA-F57D8B1D4C28}" type="datetimeFigureOut">
              <a:rPr lang="en-US" smtClean="0"/>
              <a:t>8/2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514FC3-A855-FB19-74B0-119463BB9E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A09215-750C-FCC1-FE9D-23E1174029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7B606-6021-B84F-93F3-10FDA78488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94383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775B7B-4E62-6F7F-62E3-96039CBC10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91249E8-02AF-DD6C-2007-1B54CA05A1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425296-5331-1C0D-9563-B57BFB39AD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4E27A-3637-3348-BBFA-F57D8B1D4C28}" type="datetimeFigureOut">
              <a:rPr lang="en-US" smtClean="0"/>
              <a:t>8/2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F214D3-1870-276F-E13B-E7DDC190D6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CFF79F-7B42-3A48-A9AA-BC6941FD82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7B606-6021-B84F-93F3-10FDA78488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41534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500C273-0D5B-B6B3-855A-05675D1EDAA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7BC51A8-A046-C1C4-E844-AA2A54C512D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2F9D05-E5E4-7869-0B28-3B00E55EF6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4E27A-3637-3348-BBFA-F57D8B1D4C28}" type="datetimeFigureOut">
              <a:rPr lang="en-US" smtClean="0"/>
              <a:t>8/2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8F10F9-A8A0-BB81-69A9-19CF4111C3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9625D6-16A7-8711-E2AD-9A46C697C3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7B606-6021-B84F-93F3-10FDA78488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13017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FD5FDF-AEC4-2758-0EF4-29B18706E5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2C54B3B-B156-00ED-F774-1C01CB2AB06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D4CB75-8EF2-730A-F582-628E25CD85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4E27A-3637-3348-BBFA-F57D8B1D4C28}" type="datetimeFigureOut">
              <a:rPr lang="en-US" smtClean="0"/>
              <a:t>8/2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64B120-6A02-0D57-C935-D4F1A5FF9E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903E13-1C52-99BB-C4FE-5FAE20AA8C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7B606-6021-B84F-93F3-10FDA78488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91009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A0A620-A5D8-38ED-8701-860030911A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0343E9B-72CF-6160-6D39-144CD55428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A04996-4562-F385-6156-0E10DDD385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4E27A-3637-3348-BBFA-F57D8B1D4C28}" type="datetimeFigureOut">
              <a:rPr lang="en-US" smtClean="0"/>
              <a:t>8/2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0B7C43-D8DA-8079-C010-BEA35FAD7F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6811BC-6D15-BF8F-8458-60900AF86E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7B606-6021-B84F-93F3-10FDA78488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00047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F60D15-1536-C461-3D1C-98128025F9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A4B6FA5-7F3E-CBF1-7E72-084D373EA7C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92A8FF0-F256-75B0-C7AA-16D7767D1FC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0033105-8140-F8C4-D992-C1CC326B58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4E27A-3637-3348-BBFA-F57D8B1D4C28}" type="datetimeFigureOut">
              <a:rPr lang="en-US" smtClean="0"/>
              <a:t>8/24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4C46F87-40E2-7484-CE4E-AC12ED1F32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0272238-B2D8-A062-4ABB-487A38349A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7B606-6021-B84F-93F3-10FDA78488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09637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6D76CA-8306-7454-7AED-04123D78F7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7B0C690-0F67-E06C-51B9-4B4162A917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CE8D089-F5B4-7BFC-68CF-FE7DA4A8C4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467EBF4-6C3C-FD71-2EA5-D98377BE567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5760763-6C81-6BE6-8859-DFA1288F580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CB4DCF1-FF70-C396-F843-A7F982B082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4E27A-3637-3348-BBFA-F57D8B1D4C28}" type="datetimeFigureOut">
              <a:rPr lang="en-US" smtClean="0"/>
              <a:t>8/24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E80FD5D-1425-9CBE-E14A-9FD039311F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F6E2648-089C-7EF6-EAFD-BEE5C738BE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7B606-6021-B84F-93F3-10FDA78488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10267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1B7612-58CD-4A7C-3B42-EBD156A500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33DC801-D268-8C6B-DBE3-2E8126B8BE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4E27A-3637-3348-BBFA-F57D8B1D4C28}" type="datetimeFigureOut">
              <a:rPr lang="en-US" smtClean="0"/>
              <a:t>8/24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D166F8C-ABAE-9E26-1738-4F1511067D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F420BCA-AB37-8E99-6A0D-960290DDE9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7B606-6021-B84F-93F3-10FDA78488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01693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FEC4AA8-A0F8-68C5-9386-259811E205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4E27A-3637-3348-BBFA-F57D8B1D4C28}" type="datetimeFigureOut">
              <a:rPr lang="en-US" smtClean="0"/>
              <a:t>8/24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F8D9663-926B-9ACB-AAC3-72DF5E0616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72D2208-7EBD-66C5-8B90-ADEC2C802F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7B606-6021-B84F-93F3-10FDA78488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88299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CB5EF5-118B-127E-557F-4753426FF2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A8F8118-B08F-4E33-E4FE-6FD58248C6A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58E51ED-505E-6013-FD48-6DDE0318F19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1CD604E-D666-2ED4-BD3F-71C07A2EBF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4E27A-3637-3348-BBFA-F57D8B1D4C28}" type="datetimeFigureOut">
              <a:rPr lang="en-US" smtClean="0"/>
              <a:t>8/24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9A7ACF5-C23F-5325-4AFF-69C93EF21F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3DCA21B-C2FB-1BBC-96BD-00DF9A27E0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7B606-6021-B84F-93F3-10FDA78488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40098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A15D97-A575-A2B3-4E32-A6836B51A9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FB26F96-5874-AB41-6348-8F82272801E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4D4E882-D15F-3E48-2E0C-645620AEDDD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7B98175-9208-F8A7-A3F5-556C342100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4E27A-3637-3348-BBFA-F57D8B1D4C28}" type="datetimeFigureOut">
              <a:rPr lang="en-US" smtClean="0"/>
              <a:t>8/24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C17BAB5-8344-2899-2B24-E9C22A3E46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44BCBAD-04C3-5A95-D24D-B2EFCB8D60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7B606-6021-B84F-93F3-10FDA78488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7942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62DF592-0B29-3CED-FB97-7C69BD70FF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FB93955-EFBA-533D-3A35-65ACDFD42E7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C0FA05-6DC5-3873-F70B-ED1C3D65B28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64E27A-3637-3348-BBFA-F57D8B1D4C28}" type="datetimeFigureOut">
              <a:rPr lang="en-US" smtClean="0"/>
              <a:t>8/2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DE7F91-9C8C-C214-93BA-25651AD89CA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D5D3E0-14CF-2176-0921-C78AB783775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E7B606-6021-B84F-93F3-10FDA78488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88167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31480EFC-D5CF-1584-3D00-E63B83FE475C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7066"/>
          <a:stretch/>
        </p:blipFill>
        <p:spPr>
          <a:xfrm>
            <a:off x="6095999" y="1013242"/>
            <a:ext cx="5616543" cy="36576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1CD0140-5667-0F09-AA4C-2ADAFA2312C1}"/>
              </a:ext>
            </a:extLst>
          </p:cNvPr>
          <p:cNvSpPr txBox="1"/>
          <p:nvPr/>
        </p:nvSpPr>
        <p:spPr>
          <a:xfrm>
            <a:off x="638828" y="5067348"/>
            <a:ext cx="108043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3. </a:t>
            </a:r>
            <a:r>
              <a:rPr lang="en-US" sz="1200" b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uromycilation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timulation effects of emetine and analogs in VeroE6 cells at elevated concentrations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A – Effect of 100 µM emetine (EMT) or (-) 2,3-dehydroemetine (DHE4 ) on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uromycilation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Vero E6 cells. Concentrations of 1 and 10 µM eliminate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uromycilation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main text Figure 4). B – Effect of emetine analogs on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uromycilation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Vero E6 cells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9" name="Chart 8">
            <a:extLst>
              <a:ext uri="{FF2B5EF4-FFF2-40B4-BE49-F238E27FC236}">
                <a16:creationId xmlns:a16="http://schemas.microsoft.com/office/drawing/2014/main" id="{A7D60F59-977B-169D-53B5-CD138B2D4DAF}"/>
              </a:ext>
            </a:extLst>
          </p:cNvPr>
          <p:cNvGraphicFramePr>
            <a:graphicFrameLocks noChangeAspect="1"/>
          </p:cNvGraphicFramePr>
          <p:nvPr/>
        </p:nvGraphicFramePr>
        <p:xfrm>
          <a:off x="0" y="1013242"/>
          <a:ext cx="6096000" cy="3657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03AA75D1-CA2E-CAA5-6B1E-8B8A4DB8EF0D}"/>
              </a:ext>
            </a:extLst>
          </p:cNvPr>
          <p:cNvSpPr txBox="1"/>
          <p:nvPr/>
        </p:nvSpPr>
        <p:spPr>
          <a:xfrm>
            <a:off x="9029530" y="4583160"/>
            <a:ext cx="10921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Drug, µM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E95A9D2-768E-4EEF-F819-7A7398968214}"/>
              </a:ext>
            </a:extLst>
          </p:cNvPr>
          <p:cNvSpPr txBox="1"/>
          <p:nvPr/>
        </p:nvSpPr>
        <p:spPr>
          <a:xfrm>
            <a:off x="638828" y="590323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9A08A91-149A-24BE-5F7C-F4135B09D47B}"/>
              </a:ext>
            </a:extLst>
          </p:cNvPr>
          <p:cNvSpPr txBox="1"/>
          <p:nvPr/>
        </p:nvSpPr>
        <p:spPr>
          <a:xfrm>
            <a:off x="6941507" y="590323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2813478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75</Words>
  <Application>Microsoft Macintosh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omas Rosenquist</dc:creator>
  <cp:lastModifiedBy>Thomas Rosenquist</cp:lastModifiedBy>
  <cp:revision>2</cp:revision>
  <dcterms:created xsi:type="dcterms:W3CDTF">2023-08-24T19:26:58Z</dcterms:created>
  <dcterms:modified xsi:type="dcterms:W3CDTF">2023-08-24T19:35:45Z</dcterms:modified>
</cp:coreProperties>
</file>